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  <p:sldId id="262" r:id="rId3"/>
    <p:sldId id="256" r:id="rId4"/>
  </p:sldIdLst>
  <p:sldSz cx="6858000" cy="9144000" type="letter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7CCE7"/>
    <a:srgbClr val="FBE5D6"/>
    <a:srgbClr val="BDD7EE"/>
    <a:srgbClr val="C5E0B4"/>
    <a:srgbClr val="FFFFFF"/>
    <a:srgbClr val="B1C7E5"/>
    <a:srgbClr val="BBCEE8"/>
    <a:srgbClr val="D9E3F3"/>
    <a:srgbClr val="ED7D31"/>
    <a:srgbClr val="F4B1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12" autoAdjust="0"/>
    <p:restoredTop sz="94660"/>
  </p:normalViewPr>
  <p:slideViewPr>
    <p:cSldViewPr snapToGrid="0">
      <p:cViewPr varScale="1">
        <p:scale>
          <a:sx n="89" d="100"/>
          <a:sy n="89" d="100"/>
        </p:scale>
        <p:origin x="324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347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880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75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468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600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088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969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05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76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308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7740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6A336-A7F0-49D8-A5FC-E57264352ECA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A29A1-D132-40AB-9EF5-71550491F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7157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324609" y="4282890"/>
            <a:ext cx="580817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endParaRPr lang="en-US" altLang="ja-JP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H probes and primers used in this study.</a:t>
            </a:r>
          </a:p>
        </p:txBody>
      </p:sp>
      <p:graphicFrame>
        <p:nvGraphicFramePr>
          <p:cNvPr id="21" name="表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1363326"/>
              </p:ext>
            </p:extLst>
          </p:nvPr>
        </p:nvGraphicFramePr>
        <p:xfrm>
          <a:off x="322751" y="579051"/>
          <a:ext cx="6160301" cy="370077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822346"/>
                <a:gridCol w="1485794"/>
                <a:gridCol w="1135565"/>
                <a:gridCol w="2208894"/>
                <a:gridCol w="507702"/>
              </a:tblGrid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altLang="ja-JP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erences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SH </a:t>
                      </a:r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endParaRPr kumimoji="1" lang="ja-JP" altLang="en-US" sz="7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Eub338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CCTCCCGTAGGAGT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otal</a:t>
                      </a:r>
                      <a:r>
                        <a:rPr lang="en-US" sz="7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bacteria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</a:t>
                      </a:r>
                      <a:endParaRPr lang="nb-NO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Bif15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CCCGTTTCCAGGAG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fidobacterium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Bado43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CTCCCAGTCAAAAGCG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altLang="ja-JP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dolescentis</a:t>
                      </a:r>
                      <a:endParaRPr lang="en-US" altLang="ja-JP" sz="7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b="0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Blon100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CCGTATCTCTACGACCGT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altLang="ja-JP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ngum</a:t>
                      </a:r>
                      <a:endParaRPr lang="en-US" altLang="ja-JP" sz="7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b="0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Bcat187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CACCCCATGCGAGGAGT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altLang="ja-JP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tenulatum</a:t>
                      </a:r>
                      <a:r>
                        <a:rPr lang="en-US" altLang="ja-JP" sz="700" b="0" i="1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7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roup</a:t>
                      </a:r>
                      <a:endParaRPr lang="en-US" altLang="ja-JP" sz="7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b="0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Bpl190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CACTCGCATGCGCTCAT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seudolongum</a:t>
                      </a: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roup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Bbre198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AAGGCTTTCCCAACACACC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reve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Erec48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CTTAGTCARGTACCG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pt-B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lostridium</a:t>
                      </a:r>
                      <a:r>
                        <a:rPr lang="pt-B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cluster XIVa and XIVb (</a:t>
                      </a:r>
                      <a:r>
                        <a:rPr lang="pt-BR" altLang="ja-JP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achnospiraceae</a:t>
                      </a:r>
                      <a:r>
                        <a:rPr lang="pt-B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)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7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Clept1240*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TTRTCAACGGCAGTC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7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tridium </a:t>
                      </a:r>
                      <a:r>
                        <a:rPr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tum</a:t>
                      </a:r>
                      <a:r>
                        <a:rPr lang="en-US" altLang="ja-JP" sz="7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 (</a:t>
                      </a:r>
                      <a:r>
                        <a:rPr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minococcaceae</a:t>
                      </a:r>
                      <a:r>
                        <a:rPr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Ecyl387*</a:t>
                      </a: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CGGCATTGCTCGTTCA</a:t>
                      </a:r>
                      <a:endParaRPr lang="en-US" altLang="ja-JP" sz="7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ubacterium</a:t>
                      </a: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ylindroides</a:t>
                      </a: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roup (</a:t>
                      </a:r>
                      <a:r>
                        <a:rPr lang="en-US" sz="7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rysipelotrichaceae</a:t>
                      </a: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)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9</a:t>
                      </a:r>
                      <a:endParaRPr lang="nl-NL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Bac719*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CTGCCTTCGCAATCGG</a:t>
                      </a:r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 (</a:t>
                      </a:r>
                      <a:r>
                        <a:rPr kumimoji="1"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etes</a:t>
                      </a:r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nl-NL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Ato291*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CGGTCTCTCAACCC</a:t>
                      </a:r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pobium</a:t>
                      </a:r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 (</a:t>
                      </a:r>
                      <a:r>
                        <a:rPr kumimoji="1" lang="en-US" altLang="ja-JP" sz="7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iobacteriia</a:t>
                      </a:r>
                      <a:r>
                        <a:rPr kumimoji="1" lang="en-US" altLang="ja-JP" sz="7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1</a:t>
                      </a:r>
                      <a:endParaRPr lang="nl-NL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  *only used in surveying bacterial colonization 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bg1">
                            <a:lumMod val="50000"/>
                          </a:schemeClr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 gridSpan="2"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 gridSpan="4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16S</a:t>
                      </a:r>
                      <a:r>
                        <a:rPr lang="ja-JP" altLang="en-US" sz="7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7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bial profiling (underlined sequences hybridize to 16S </a:t>
                      </a:r>
                      <a:r>
                        <a:rPr lang="en-US" altLang="ja-JP" sz="700" u="none" strike="noStrike" baseline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NA</a:t>
                      </a:r>
                      <a:r>
                        <a:rPr lang="en-US" altLang="ja-JP" sz="7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, NNNNNNNNNNNN represents 12-base </a:t>
                      </a:r>
                      <a:r>
                        <a:rPr lang="en-US" altLang="ja-JP" sz="700" u="none" strike="noStrike" baseline="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lay</a:t>
                      </a:r>
                      <a:r>
                        <a:rPr lang="en-US" altLang="ja-JP" sz="7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arcode)</a:t>
                      </a:r>
                      <a:endParaRPr lang="ja-JP" alt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2, 12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27Fmod2-MiSeq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GATACGGCGACCACCGAGATCTACACTCTTTCCCTACACGACGCTCTTCCGATCT</a:t>
                      </a:r>
                      <a:r>
                        <a:rPr lang="en-US" sz="700" u="sng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RGTTYGATYMTGGCTCAG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338R-MiSeq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GCAGAAGACGGCATACGAGAT-</a:t>
                      </a:r>
                      <a:r>
                        <a:rPr lang="en-US" sz="70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NNNNNNNNNN</a:t>
                      </a:r>
                      <a:r>
                        <a:rPr lang="en-US" sz="70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ACTGGAGTTCAGACGTGTGCTCTTCCGATCT</a:t>
                      </a:r>
                      <a:r>
                        <a:rPr lang="en-US" sz="700" u="sng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CCWCCCGTAGGWGT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2976" marR="2976" marT="297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RAP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Primer </a:t>
                      </a:r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CAGCCA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Primer </a:t>
                      </a:r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GCGCAA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Primer </a:t>
                      </a:r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GTCGGT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4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16S </a:t>
                      </a:r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27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GTTTGATCMTGGCTCA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5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Bi8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GTTYCGATTCTGGCTCAGGAT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6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1522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GAGGTGATCCARCCG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7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520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GCGGCTGCTGGC</a:t>
                      </a: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6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etition assa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endParaRPr kumimoji="1" lang="ja-JP" alt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27Fmod2-nota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7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RGTTYGATYMTGGCTCA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, 12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  g-Bifid-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TGTTCTTCCCGATATCTA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>
                    <a:noFill/>
                  </a:tcPr>
                </a:tc>
              </a:tr>
              <a:tr h="105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Clept866m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GGTGGATWACTTATTGTGTTA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</a:t>
                      </a:r>
                      <a:endParaRPr lang="ja-JP" alt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2232" marR="2232" marT="2232" marB="0" anchor="ctr">
                    <a:noFill/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515826" y="4568327"/>
            <a:ext cx="5826348" cy="4336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16000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s</a:t>
            </a:r>
          </a:p>
          <a:p>
            <a:pPr defTabSz="216000"/>
            <a:endParaRPr lang="en-US" altLang="ja-JP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ann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I, Binder BJ, Olson RJ, Chisholm SW, Devereux R, Stahl DA. Combination of 16S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rgeted oligonucleotide probes 	with flow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nalyzing mixed microbial population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1990; 56: 1919–1925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6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Takada T, Matsumoto K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moto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. Development of multi-color FISH method for analysis of seven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fidobacterium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in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human feces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J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hods. 2004; 58: 413–421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7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Franks AH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msen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J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angs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C, Jansen GJ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u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, Welling GW. Variations of bacterial populations in human feces measured 	by fluorescent 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with group-specific 16S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rgeted oligonucleotide probe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1998;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64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36–3345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hir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me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au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che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char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, Dore J. Quantification of bacterial groups within human fecal flora by 	oligonucleotide probe hybridization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0; 66: 2263–2266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9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rmie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MH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rwin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, He T, John ED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jal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W. Extensive set of 16S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probes for detection of bacteria in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man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fece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2; 68: 2982–2990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aishi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suki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kazaw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Takada T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do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ahar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et al. Imbalance in intestinal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flor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itution could be 	involved in the pathogenesis of inflammatory bowel disease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 Med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8; 298: 463–472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1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msen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J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ldeboer-Veloo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ijpstr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n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ener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E, Welling GW. Development of 16S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probes for the 	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iobacterium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and the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opobium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and their application for enumeration of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iobacteriaceae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human feces from 	volunteers of different age group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0; 66: 4523–4527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2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Kato-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aok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Nishida K, Takada M, Kawai M, Kikuchi-Hayakawa H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d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 et al. Fermented milk containing 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ja-JP" sz="788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i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ai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ja-JP" sz="788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rota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rves the diversity of the gut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t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lieves abdominal dysfunction in healthy medical students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exposed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ademic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s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16; 82: 3649–3658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3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opyanz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kanov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stblom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sovich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Berg DE. DNA diversity among clinical isolates of 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icobacter pylori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detected by PCR-based RAPD fingerprinting. Nucleic Acids Res. 1992; 20: 5137–5142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4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Yuki N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mazaki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, Kushiro A, Watanabe K, Uchida K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yam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et al. Colonization of the stratified squamous epithelium of the 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secreting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of horse stomach by Lactobacilli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0; 66: 5030–5034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Lane DJ. 16S/23S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ing. In: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ckebrandt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odfellow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s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Nucleic Acid Techniques in Bacterial Systematics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	(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hn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ey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ons, New York, NY, 1991) pp 115–175.</a:t>
            </a:r>
          </a:p>
          <a:p>
            <a:pPr defTabSz="216000"/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6.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	Miyake T, Watanabe K, Watanabe T, Oyaizu H. Phylogenetic analysis of the genus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fidobacterium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lated genera based on 16S 	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DN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.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l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1998; 42: 661–667.</a:t>
            </a:r>
          </a:p>
          <a:p>
            <a:pPr marL="228600" indent="-228600" defTabSz="216000">
              <a:buAutoNum type="arabicPeriod" startAt="57"/>
            </a:pP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hnson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JL. Similarity analysis of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s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: Gerhardt PE, Wood WA, Krieg NR (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s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Methods for General and Molecular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teriology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merican Society of Microbiology, Washington, DC, 1994) pp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83–700.</a:t>
            </a:r>
          </a:p>
          <a:p>
            <a:pPr marL="228600" indent="-228600" defTabSz="216000">
              <a:buAutoNum type="arabicPeriod" startAt="57"/>
            </a:pP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irez-Farias C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ezak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, Fuller Z, Duncan A,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ltrop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, Louis P. Effect of inulin on the human gut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ta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timulation of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fidobacterium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olescentis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ecalibacterium</a:t>
            </a:r>
            <a:r>
              <a:rPr lang="en-US" altLang="ja-JP" sz="78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88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ausnitzii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r J </a:t>
            </a:r>
            <a:r>
              <a:rPr lang="en-US" altLang="ja-JP" sz="78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tr</a:t>
            </a:r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788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9;101:541-550.</a:t>
            </a:r>
            <a:endParaRPr lang="en-US" altLang="ja-JP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216000"/>
            <a:endParaRPr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8733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47111" y="7156317"/>
            <a:ext cx="616377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 for starch-utilizing ability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s were screened for their ability to degrade soluble starch and to bind to starch granules. The isolates with at least weakly positive results were analyzed further (</a:t>
            </a:r>
            <a:r>
              <a:rPr lang="en-US" altLang="ja-JP" sz="90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ja-JP" sz="9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).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: ++ aggregates precipitate making the supernatant transparent; + some aggregates form; − no aggregation. Generation of an unstained zone (ability to degrade soluble starch): ++ large clear zone around the colony; + clear zone of a medium size; w (weak) iodine staining remains or clear zone is &lt; 1 mm; − staining around the colony is not reduced; v (variable) varies in different experiments from “−“ to “w</a:t>
            </a:r>
            <a:r>
              <a:rPr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”. All strains showed the same binding ability to corn starch.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7322792"/>
              </p:ext>
            </p:extLst>
          </p:nvPr>
        </p:nvGraphicFramePr>
        <p:xfrm>
          <a:off x="1358863" y="578184"/>
          <a:ext cx="4590822" cy="6329177"/>
        </p:xfrm>
        <a:graphic>
          <a:graphicData uri="http://schemas.openxmlformats.org/drawingml/2006/table">
            <a:tbl>
              <a:tblPr/>
              <a:tblGrid>
                <a:gridCol w="982250"/>
                <a:gridCol w="1758537"/>
                <a:gridCol w="323207"/>
                <a:gridCol w="763414"/>
                <a:gridCol w="763414"/>
              </a:tblGrid>
              <a:tr h="1687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amily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Identific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train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nding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to</a:t>
                      </a:r>
                    </a:p>
                    <a:p>
                      <a:pPr algn="ctr" fontAlgn="ctr"/>
                      <a:r>
                        <a:rPr lang="en-US" altLang="ja-JP" sz="8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aw potato 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tarch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eneration of unstained 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zone around colony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ifidobacteriaceae</a:t>
                      </a:r>
                      <a:endParaRPr lang="en-US" altLang="ja-JP" sz="8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ifidobacterium</a:t>
                      </a:r>
                      <a:r>
                        <a:rPr lang="en-US" altLang="ja-JP" sz="8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dolescentis</a:t>
                      </a:r>
                      <a:endParaRPr lang="en-US" altLang="ja-JP" sz="8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2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 +</a:t>
                      </a:r>
                      <a:endParaRPr kumimoji="1" lang="ja-JP" altLang="en-US" sz="8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fido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atenulatum</a:t>
                      </a:r>
                      <a:r>
                        <a:rPr lang="ja-JP" altLang="en-US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r.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w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E5D6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−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fido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ongu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　　　　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77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772" rtl="0" eaLnBrk="1" fontAlgn="ctr" latinLnBrk="0" hangingPunct="1"/>
                      <a:r>
                        <a:rPr kumimoji="1"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kumimoji="1" lang="en-US" sz="8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2</a:t>
                      </a:r>
                      <a:endParaRPr kumimoji="1" lang="en-US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fido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ifid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oriobacteri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ollinsell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erofaciens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7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aceae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xylanisolve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ulg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tercor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hetaiotaomicron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uniform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4B183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acteroid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aec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achnospiraceae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ubacterium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ctale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6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u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entrios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w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E5D6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u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]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allii</a:t>
                      </a:r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95.9%)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−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ubacteri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]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alli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</a:t>
                      </a:r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E5D6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naerostipe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adr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laut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uti</a:t>
                      </a:r>
                      <a:r>
                        <a:rPr lang="en-US" altLang="ja-JP" sz="8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97.0%)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w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E5D6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laut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ut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laut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tercor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uminococc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]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nav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uminococc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]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be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uminococc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aec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ore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rmicigenera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−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rysipelotrich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ielm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astidiosa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6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ja-JP" sz="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+</a:t>
                      </a:r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eillonell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egasphaer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assiliensis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07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nterobacteri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scherichia coli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7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D7EE"/>
                    </a:solidFill>
                  </a:tcPr>
                </a:tc>
              </a:tr>
              <a:tr h="168776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nterobacter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udwigii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−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47164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1744707"/>
              </p:ext>
            </p:extLst>
          </p:nvPr>
        </p:nvGraphicFramePr>
        <p:xfrm>
          <a:off x="852509" y="1439788"/>
          <a:ext cx="4956957" cy="490357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45654"/>
                <a:gridCol w="645654"/>
                <a:gridCol w="791447"/>
                <a:gridCol w="531103"/>
                <a:gridCol w="781033"/>
                <a:gridCol w="781033"/>
                <a:gridCol w="781033"/>
              </a:tblGrid>
              <a:tr h="3124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nam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ry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ilization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b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iled potato starc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ilization of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w potato starc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ng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</a:t>
                      </a:r>
                      <a:b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w</a:t>
                      </a:r>
                      <a:r>
                        <a:rPr lang="en-US" sz="8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tato 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c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11</a:t>
                      </a:r>
                      <a:r>
                        <a:rPr lang="en-US" sz="80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C 157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0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2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Ew10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Bw104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Lw104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Hw104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Kw104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-Lw104b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a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-7</a:t>
                      </a:r>
                      <a:endParaRPr lang="en-US" altLang="ja-JP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-7</a:t>
                      </a:r>
                      <a:endParaRPr lang="en-US" altLang="ja-JP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-8</a:t>
                      </a:r>
                      <a:endParaRPr lang="en-US" altLang="ja-JP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-9</a:t>
                      </a:r>
                      <a:endParaRPr lang="en-US" altLang="ja-JP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-3</a:t>
                      </a:r>
                      <a:endParaRPr lang="en-US" altLang="ja-JP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B-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giu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0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03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03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03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</a:t>
                      </a:r>
                      <a:r>
                        <a:rPr 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2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260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CM 1591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re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4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DO 22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46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DO 22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4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DO 22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8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CM 70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ul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04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erl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04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erl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1189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erl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－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1562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T 405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CM 12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vine lume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al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＋</a:t>
                      </a:r>
                      <a:r>
                        <a:rPr lang="en-US" altLang="ja-JP" sz="8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10" marR="7810" marT="7810" marB="0" anchor="ctr">
                    <a:solidFill>
                      <a:schemeClr val="accent2"/>
                    </a:solidFill>
                  </a:tcPr>
                </a:tc>
              </a:tr>
            </a:tbl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714861" y="6376259"/>
            <a:ext cx="551747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and utilization of </a:t>
            </a:r>
            <a:r>
              <a:rPr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w potato starch </a:t>
            </a:r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nules by </a:t>
            </a:r>
            <a:r>
              <a:rPr lang="en-US" altLang="ja-JP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ja-JP" sz="9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olescentis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tilization: + pH &lt; 5; − pH &gt; 6. Binding: + aggregates precipitate making the supernatant transparent; − no aggregation. ND: not determined because of self-aggregation of bacterial cells. All strains showed the same binding ability to corn </a:t>
            </a:r>
            <a:r>
              <a:rPr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ch.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binding was confirmed after overnight incubation with granules in optimal broth.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8397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3</TotalTime>
  <Words>854</Words>
  <Application>Microsoft Office PowerPoint</Application>
  <PresentationFormat>レター サイズ 8.5x11 インチ</PresentationFormat>
  <Paragraphs>48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柄 雄介</dc:creator>
  <cp:lastModifiedBy>長柄 雄介</cp:lastModifiedBy>
  <cp:revision>140</cp:revision>
  <cp:lastPrinted>2021-02-08T01:15:04Z</cp:lastPrinted>
  <dcterms:created xsi:type="dcterms:W3CDTF">2020-05-20T00:14:24Z</dcterms:created>
  <dcterms:modified xsi:type="dcterms:W3CDTF">2021-12-27T10:21:27Z</dcterms:modified>
</cp:coreProperties>
</file>